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dditional file 11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09600" y="1371600"/>
            <a:ext cx="7620000" cy="502443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06400" y="628651"/>
            <a:ext cx="820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 smtClean="0"/>
              <a:t>Figure S7a</a:t>
            </a:r>
            <a:r>
              <a:rPr lang="en-IN" dirty="0" smtClean="0"/>
              <a:t>. </a:t>
            </a:r>
            <a:r>
              <a:rPr lang="en-IN" dirty="0" smtClean="0"/>
              <a:t>Correlation among the bacterial </a:t>
            </a:r>
            <a:r>
              <a:rPr lang="en-IN" dirty="0" smtClean="0"/>
              <a:t>families in </a:t>
            </a:r>
            <a:r>
              <a:rPr lang="en-IN" dirty="0" smtClean="0"/>
              <a:t>the gut of </a:t>
            </a:r>
            <a:r>
              <a:rPr lang="en-IN" dirty="0" err="1" smtClean="0"/>
              <a:t>Aseel</a:t>
            </a:r>
            <a:endParaRPr lang="en-IN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dditional file 12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35000" y="1295400"/>
            <a:ext cx="7975600" cy="4948238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320800" y="400050"/>
            <a:ext cx="7112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b="1" dirty="0" smtClean="0"/>
              <a:t>Figure S7b</a:t>
            </a:r>
            <a:r>
              <a:rPr lang="en-IN" dirty="0" smtClean="0"/>
              <a:t>. </a:t>
            </a:r>
            <a:r>
              <a:rPr lang="en-IN" dirty="0" smtClean="0"/>
              <a:t>Correlation among the bacterial families in the gut of the broiler line </a:t>
            </a:r>
            <a:r>
              <a:rPr lang="en-IN" dirty="0" err="1" smtClean="0"/>
              <a:t>VenCobb</a:t>
            </a:r>
            <a:r>
              <a:rPr lang="en-IN" dirty="0" smtClean="0"/>
              <a:t> 400</a:t>
            </a:r>
            <a:endParaRPr lang="en-IN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dditional file 13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62000" y="1143000"/>
            <a:ext cx="7747000" cy="515778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117600" y="285751"/>
            <a:ext cx="7112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b="1" dirty="0" smtClean="0"/>
              <a:t>Figure S7c</a:t>
            </a:r>
            <a:r>
              <a:rPr lang="en-IN" dirty="0" smtClean="0"/>
              <a:t>. </a:t>
            </a:r>
            <a:r>
              <a:rPr lang="en-IN" dirty="0" smtClean="0"/>
              <a:t>Correlation among the bacterial families in the gut of </a:t>
            </a:r>
            <a:r>
              <a:rPr lang="en-IN" dirty="0" err="1" smtClean="0"/>
              <a:t>Ghagus</a:t>
            </a:r>
            <a:endParaRPr lang="en-IN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dditional file 14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35000" y="1066800"/>
            <a:ext cx="7975600" cy="534828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117600" y="342901"/>
            <a:ext cx="7721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b="1" smtClean="0"/>
              <a:t>Figure S7d</a:t>
            </a:r>
            <a:r>
              <a:rPr lang="en-IN" smtClean="0"/>
              <a:t>. </a:t>
            </a:r>
            <a:r>
              <a:rPr lang="en-IN" dirty="0" smtClean="0"/>
              <a:t>Correlation among the bacterial families  in the gut of </a:t>
            </a:r>
            <a:r>
              <a:rPr lang="en-IN" dirty="0" err="1" smtClean="0"/>
              <a:t>Nicobari</a:t>
            </a:r>
            <a:endParaRPr lang="en-IN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6</Words>
  <Application>Microsoft Office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yam</dc:creator>
  <cp:lastModifiedBy>Shyam</cp:lastModifiedBy>
  <cp:revision>3</cp:revision>
  <dcterms:created xsi:type="dcterms:W3CDTF">2006-08-16T00:00:00Z</dcterms:created>
  <dcterms:modified xsi:type="dcterms:W3CDTF">2020-12-20T13:02:28Z</dcterms:modified>
</cp:coreProperties>
</file>